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DE148-8F67-426F-9D45-3E466E075F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5BCBB-4A14-481C-96C5-0576B55759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11AFF-F5B7-4417-A717-D7EA14506C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5FF07-3996-48F9-BD28-CAC329FC96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AD355-EDAE-4085-8580-B6AFEAF658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67BCA-0D62-4120-990E-D9269D2D91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C3E6E-692A-4BC9-B4E6-4476D8451E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E9806E-1B82-44AE-93D0-A36A9C19CD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31EE1-386B-4429-A122-AD6C53E587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1D269A-0B12-4767-B4E2-45F88B6110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8F780-3170-4EFA-B88F-9D1D52FDD3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06F48-6520-4B93-AA75-41D8117923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3C7550-7ED6-4179-B180-49E968A8024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387520" y="463680"/>
            <a:ext cx="40132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Cas1 family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 baltic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OS18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 flipV="1">
            <a:off x="2371680" y="506520"/>
            <a:ext cx="14400" cy="71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389320" y="603360"/>
            <a:ext cx="35542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Cas1 family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 baltic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OS19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371680" y="577800"/>
            <a:ext cx="1440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V="1">
            <a:off x="2278080" y="577800"/>
            <a:ext cx="93600" cy="139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397240" y="746280"/>
            <a:ext cx="3470040" cy="15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Cas1 family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p  W3 18 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V="1">
            <a:off x="2374920" y="789120"/>
            <a:ext cx="2052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471760" y="885960"/>
            <a:ext cx="3395520" cy="10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protein Cas1  </a:t>
            </a:r>
            <a:r>
              <a:rPr b="0" i="1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 putrefaciens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 200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374920" y="858960"/>
            <a:ext cx="93600" cy="71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278080" y="717480"/>
            <a:ext cx="96840" cy="141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1676520" y="717120"/>
            <a:ext cx="601560" cy="28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403360" y="1027080"/>
            <a:ext cx="354024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TD2 15272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seudoalteromonas tunicat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D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676520" y="1000080"/>
            <a:ext cx="72396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1592280" y="999720"/>
            <a:ext cx="84240" cy="141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878200" y="1168560"/>
            <a:ext cx="306540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PROSTU 02035  </a:t>
            </a:r>
            <a:r>
              <a:rPr b="0" i="1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Providencia stuartii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ATCC 25827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1755720" y="1212840"/>
            <a:ext cx="111924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752560" y="1309680"/>
            <a:ext cx="364824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protein Cas1  </a:t>
            </a:r>
            <a:r>
              <a:rPr b="0" i="1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Vibrio cholerae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 RC38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755720" y="1282680"/>
            <a:ext cx="99396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592280" y="1141560"/>
            <a:ext cx="163440" cy="141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1360440" y="1141560"/>
            <a:ext cx="231840" cy="280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462040" y="1450800"/>
            <a:ext cx="3405240" cy="15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BPRB1995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hotobacterium profundum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S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1495440" y="1494000"/>
            <a:ext cx="96372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397240" y="1592280"/>
            <a:ext cx="1869840" cy="15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KT99 16499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 benthic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KT9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495440" y="1563840"/>
            <a:ext cx="900000" cy="71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360440" y="1422360"/>
            <a:ext cx="135000" cy="141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1123920" y="1422000"/>
            <a:ext cx="236520" cy="28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690640" y="1731960"/>
            <a:ext cx="203868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Dugway 5J108 11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2668680" y="1775880"/>
            <a:ext cx="19080" cy="70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741760" y="1873080"/>
            <a:ext cx="181584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CbuG Q21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668680" y="1846440"/>
            <a:ext cx="69840" cy="71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123920" y="1704960"/>
            <a:ext cx="1544760" cy="141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V="1">
            <a:off x="939960" y="1704600"/>
            <a:ext cx="183960" cy="28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673360" y="2014560"/>
            <a:ext cx="281304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ABAYE0995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Acinetobacter baumann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AY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V="1">
            <a:off x="1025640" y="2057400"/>
            <a:ext cx="164448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639160" y="2154240"/>
            <a:ext cx="2170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pa01472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. Alcoy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1803240" y="2198520"/>
            <a:ext cx="83520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550960" y="2297160"/>
            <a:ext cx="1947960" cy="15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lpl0052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Len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2535120" y="2340000"/>
            <a:ext cx="792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557440" y="2436840"/>
            <a:ext cx="190980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pl2837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Len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535120" y="2409840"/>
            <a:ext cx="19080" cy="71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803240" y="2268360"/>
            <a:ext cx="731880" cy="141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025640" y="2127240"/>
            <a:ext cx="777600" cy="141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939960" y="1987560"/>
            <a:ext cx="85680" cy="139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836640" y="1987200"/>
            <a:ext cx="103320" cy="563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977920" y="2577960"/>
            <a:ext cx="2432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MITSMUL 00792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Mitsuokella multacid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DSM 20544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836640" y="2550960"/>
            <a:ext cx="2141640" cy="69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700200" y="2550960"/>
            <a:ext cx="1364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108080" y="2816280"/>
            <a:ext cx="452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108080" y="2793960"/>
            <a:ext cx="0" cy="44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560600" y="2793960"/>
            <a:ext cx="1440" cy="44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278000" y="2840040"/>
            <a:ext cx="257040" cy="13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MS Mincho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652760" y="3122640"/>
            <a:ext cx="2737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pt-PT" sz="800" spc="-1" strike="noStrike">
                <a:solidFill>
                  <a:srgbClr val="000000"/>
                </a:solidFill>
                <a:latin typeface="Arial"/>
                <a:ea typeface="MS Mincho"/>
              </a:rPr>
              <a:t>PM0312  </a:t>
            </a:r>
            <a:r>
              <a:rPr b="0" i="1" lang="pt-PT" sz="800" spc="-1" strike="noStrike">
                <a:solidFill>
                  <a:srgbClr val="000000"/>
                </a:solidFill>
                <a:latin typeface="Arial"/>
                <a:ea typeface="MS Mincho"/>
              </a:rPr>
              <a:t>Pasteurella multocida</a:t>
            </a:r>
            <a:r>
              <a:rPr b="0" lang="pt-PT" sz="800" spc="-1" strike="noStrike">
                <a:solidFill>
                  <a:srgbClr val="000000"/>
                </a:solidFill>
                <a:latin typeface="Arial"/>
                <a:ea typeface="MS Mincho"/>
              </a:rPr>
              <a:t> subsp  multocida str  Pm70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1289160" y="3165120"/>
            <a:ext cx="36360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430280" y="3252960"/>
            <a:ext cx="2864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helicase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Actinobacillus pleuropneumonia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erovar 3 str  JL0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1428840" y="3297240"/>
            <a:ext cx="0" cy="1317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431360" y="3384720"/>
            <a:ext cx="3006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APP7 0215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Actinobacillus pleuropneumonia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erovar 7 str  AP76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428840" y="3429000"/>
            <a:ext cx="0" cy="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431720" y="3516480"/>
            <a:ext cx="3895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G1203  Predicted helicases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Actinobacillus pleuropneumonia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erovar 1 str  4074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428840" y="3429000"/>
            <a:ext cx="0" cy="1317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1289160" y="3230640"/>
            <a:ext cx="139680" cy="1983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V="1">
            <a:off x="934920" y="3230640"/>
            <a:ext cx="354240" cy="3952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509120" y="3648240"/>
            <a:ext cx="3384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helicase Cas3 family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Tolumonas auensi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DSM 9187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flipV="1">
            <a:off x="1147680" y="3692160"/>
            <a:ext cx="36216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624320" y="3780000"/>
            <a:ext cx="2897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nserved hypothetical protein  delta proteobacterium MLMS 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147680" y="3757680"/>
            <a:ext cx="47304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1073160" y="3757680"/>
            <a:ext cx="74520" cy="1317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982880" y="3911760"/>
            <a:ext cx="1739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UTI89 C0891  </a:t>
            </a:r>
            <a:r>
              <a:rPr b="0" i="1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Escherichia coli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UTI8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1981080" y="3955680"/>
            <a:ext cx="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980720" y="4043520"/>
            <a:ext cx="2806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putative CRISPR associated helicase  </a:t>
            </a:r>
            <a:r>
              <a:rPr b="0" i="1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Escherichia coli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ED1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981080" y="4022640"/>
            <a:ext cx="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1974960" y="4022640"/>
            <a:ext cx="6120" cy="1303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057760" y="4175280"/>
            <a:ext cx="3121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helicase Cas3  yersinia type  </a:t>
            </a:r>
            <a:r>
              <a:rPr b="0" i="1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Escherichia coli</a:t>
            </a:r>
            <a:r>
              <a:rPr b="0" lang="it-IT" sz="800" spc="-1" strike="noStrike">
                <a:solidFill>
                  <a:srgbClr val="000000"/>
                </a:solidFill>
                <a:latin typeface="Arial"/>
                <a:ea typeface="MS Mincho"/>
              </a:rPr>
              <a:t> B7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974960" y="4152960"/>
            <a:ext cx="8568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 flipV="1">
            <a:off x="1700280" y="4152960"/>
            <a:ext cx="274680" cy="1332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761840" y="4307040"/>
            <a:ext cx="3275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helicase Cas3 family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Enterobacter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p  638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700280" y="4286160"/>
            <a:ext cx="6012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flipV="1">
            <a:off x="1654200" y="4286160"/>
            <a:ext cx="46080" cy="1303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007720" y="4438800"/>
            <a:ext cx="2716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ENTCAN 01660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Enterobacter cancerogenu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ATCC 35316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654200" y="4416480"/>
            <a:ext cx="34920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flipV="1">
            <a:off x="1158840" y="4416480"/>
            <a:ext cx="495360" cy="1332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431720" y="4570560"/>
            <a:ext cx="276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plu1791  </a:t>
            </a:r>
            <a:r>
              <a:rPr b="0" i="1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Photorhabdus luminescens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  <a:ea typeface="MS Mincho"/>
              </a:rPr>
              <a:t> subsp  laumondii TTO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V="1">
            <a:off x="1287360" y="4614480"/>
            <a:ext cx="14148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526760" y="4702320"/>
            <a:ext cx="2788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helicase  Cas3 family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Erwinia pyrifolia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1471680" y="4746240"/>
            <a:ext cx="5724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567800" y="4834080"/>
            <a:ext cx="1882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ETA 08390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Erwinia tasmaniensi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Et1 9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471680" y="4813200"/>
            <a:ext cx="9360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287360" y="4680000"/>
            <a:ext cx="184320" cy="1332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1211400" y="4680000"/>
            <a:ext cx="75960" cy="2635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519200" y="4965840"/>
            <a:ext cx="237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ECA3680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ectobacterium atrosepticum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CRI104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211400" y="4943520"/>
            <a:ext cx="30456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1158840" y="4549680"/>
            <a:ext cx="52560" cy="39384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073160" y="3889440"/>
            <a:ext cx="85680" cy="66024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934920" y="3625920"/>
            <a:ext cx="138240" cy="2635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flipV="1">
            <a:off x="838080" y="3625920"/>
            <a:ext cx="96840" cy="14508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2225880" y="5097600"/>
            <a:ext cx="2182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pa01473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. Alcoy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V="1">
            <a:off x="1374840" y="5141520"/>
            <a:ext cx="84924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634120" y="5229360"/>
            <a:ext cx="2140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TD2 15277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seudoalteromonas tunicat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D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flipV="1">
            <a:off x="2444760" y="5273280"/>
            <a:ext cx="18432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845080" y="5361120"/>
            <a:ext cx="2740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dead deah box helicase  N terminal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Vibrio cholera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RC38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flipV="1">
            <a:off x="2646360" y="5405040"/>
            <a:ext cx="19368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742480" y="5492880"/>
            <a:ext cx="2801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DEAD DEAH box helicase like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 putrefacien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200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V="1">
            <a:off x="2722680" y="5536800"/>
            <a:ext cx="1728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743200" y="5624640"/>
            <a:ext cx="2989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DEAD like helicases like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 putrefacien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CN 3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722680" y="5602320"/>
            <a:ext cx="2052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646360" y="5470560"/>
            <a:ext cx="76320" cy="1317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flipV="1">
            <a:off x="2617920" y="5470560"/>
            <a:ext cx="28440" cy="2635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033720" y="5756400"/>
            <a:ext cx="2141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BPRB1994  Photobacterium profundum SS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617920" y="5734080"/>
            <a:ext cx="41112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444760" y="5338800"/>
            <a:ext cx="173160" cy="39528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V="1">
            <a:off x="1893960" y="5338800"/>
            <a:ext cx="550800" cy="52704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929240" y="5888160"/>
            <a:ext cx="3523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helicase Cas3 family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 baltic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OS18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893960" y="5865840"/>
            <a:ext cx="3312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1851120" y="5865840"/>
            <a:ext cx="42840" cy="1332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936800" y="6019920"/>
            <a:ext cx="3524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helicase Cas3 family protein  Shewanella baltica OS195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851120" y="5999040"/>
            <a:ext cx="8388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1476360" y="5999040"/>
            <a:ext cx="374760" cy="1303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169720" y="6151680"/>
            <a:ext cx="1997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lpl0051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Len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flipV="1">
            <a:off x="2048040" y="6195600"/>
            <a:ext cx="11736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442600" y="6283440"/>
            <a:ext cx="1940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pl2838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Len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048040" y="6262560"/>
            <a:ext cx="388800" cy="6516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1627200" y="6262560"/>
            <a:ext cx="420840" cy="1303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013120" y="6415200"/>
            <a:ext cx="201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ABAYE0996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Acinetobacter baumann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AY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627200" y="6392880"/>
            <a:ext cx="382680" cy="6660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1476360" y="6129360"/>
            <a:ext cx="150840" cy="2635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374840" y="5207040"/>
            <a:ext cx="101520" cy="9223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838080" y="5076720"/>
            <a:ext cx="536760" cy="13032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700200" y="5076720"/>
            <a:ext cx="137880" cy="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112760" y="6645240"/>
            <a:ext cx="257400" cy="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112760" y="6622920"/>
            <a:ext cx="0" cy="4284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370160" y="6622920"/>
            <a:ext cx="1440" cy="42840"/>
          </a:xfrm>
          <a:prstGeom prst="line">
            <a:avLst/>
          </a:prstGeom>
          <a:ln w="57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198800" y="66769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MS Mincho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123360" y="7107120"/>
            <a:ext cx="2140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TD2 15292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seudoalteromonas tunicat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D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V="1">
            <a:off x="2571840" y="7161120"/>
            <a:ext cx="546120" cy="84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3381480" y="7275600"/>
            <a:ext cx="3257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protein  Csy4 family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Shewanella putrefacien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200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flipV="1">
            <a:off x="2984400" y="7329240"/>
            <a:ext cx="395280" cy="83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470040" y="7443720"/>
            <a:ext cx="214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BPRB1991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hotobacterium profundum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S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984400" y="7413480"/>
            <a:ext cx="480960" cy="84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571840" y="7245360"/>
            <a:ext cx="412560" cy="168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flipV="1">
            <a:off x="873000" y="7245000"/>
            <a:ext cx="1698840" cy="336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2941560" y="7613640"/>
            <a:ext cx="3051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hypothetical cytosolic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Dugway 5J108 11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flipV="1">
            <a:off x="2928960" y="7665840"/>
            <a:ext cx="9360" cy="83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2973240" y="7781760"/>
            <a:ext cx="3052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Csy4 family protein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RSA 331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flipV="1">
            <a:off x="2948040" y="7835760"/>
            <a:ext cx="25200" cy="82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999880" y="7950240"/>
            <a:ext cx="2722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hypothetical cytosolic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CbuG Q21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948040" y="7918560"/>
            <a:ext cx="49320" cy="85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928960" y="7750080"/>
            <a:ext cx="19080" cy="168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flipV="1">
            <a:off x="2911320" y="7750080"/>
            <a:ext cx="17640" cy="338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911320" y="8118360"/>
            <a:ext cx="3081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RISPR associated Csy4 family protein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Coxiella burnetii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RSA 493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911320" y="8088480"/>
            <a:ext cx="1800" cy="83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flipV="1">
            <a:off x="1393920" y="8088120"/>
            <a:ext cx="1517400" cy="168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955960" y="8286840"/>
            <a:ext cx="2153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pa01476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Alco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V="1">
            <a:off x="1620720" y="8340480"/>
            <a:ext cx="1333440" cy="838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433240" y="8454960"/>
            <a:ext cx="1997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plpl0047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Len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V="1">
            <a:off x="2362320" y="8508960"/>
            <a:ext cx="64800" cy="84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482200" y="8623440"/>
            <a:ext cx="1940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pl2842  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Legionella pneumophila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MS Mincho"/>
              </a:rPr>
              <a:t> str  Len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362320" y="8593200"/>
            <a:ext cx="114120" cy="84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1620720" y="8424720"/>
            <a:ext cx="741600" cy="168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393920" y="8256600"/>
            <a:ext cx="226800" cy="168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873000" y="7581960"/>
            <a:ext cx="520920" cy="674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711360" y="7581960"/>
            <a:ext cx="1616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1197000" y="8908920"/>
            <a:ext cx="455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1197000" y="888372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1652760" y="8883720"/>
            <a:ext cx="0" cy="50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1373400" y="89456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MS Mincho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648720" y="425880"/>
            <a:ext cx="67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a) Cas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648000" y="3000960"/>
            <a:ext cx="688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b) Cas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647640" y="6804720"/>
            <a:ext cx="1041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8604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604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604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MS Mincho"/>
              </a:rPr>
              <a:t>c) Csy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8604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09T09:34:06Z</dcterms:created>
  <dc:creator>gdauria</dc:creator>
  <dc:description/>
  <dc:language>en-US</dc:language>
  <cp:lastModifiedBy>gdauria</cp:lastModifiedBy>
  <dcterms:modified xsi:type="dcterms:W3CDTF">2009-09-09T09:41:39Z</dcterms:modified>
  <cp:revision>1</cp:revision>
  <dc:subject/>
  <dc:title>Diapositiva 1</dc:title>
</cp:coreProperties>
</file>